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02438" cy="99345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3" name="作成者" initials="作成者" lastIdx="0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00CC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14" y="3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98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2863" y="0"/>
            <a:ext cx="2947987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5FB298-0B85-4532-8005-BAB28678C22C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9688" cy="37258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1038" y="4719638"/>
            <a:ext cx="5441950" cy="44704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436100"/>
            <a:ext cx="294798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2863" y="9436100"/>
            <a:ext cx="2947987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8C0700-5BE6-4C7D-8621-AE01BCAE95C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232947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18C0700-5BE6-4C7D-8621-AE01BCAE95C5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281707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254653302"/>
              </p:ext>
            </p:extLst>
          </p:nvPr>
        </p:nvGraphicFramePr>
        <p:xfrm>
          <a:off x="548680" y="992560"/>
          <a:ext cx="5760640" cy="1512168"/>
        </p:xfrm>
        <a:graphic>
          <a:graphicData uri="http://schemas.openxmlformats.org/drawingml/2006/table">
            <a:tbl>
              <a:tblPr/>
              <a:tblGrid>
                <a:gridCol w="486815"/>
                <a:gridCol w="567950"/>
                <a:gridCol w="649086"/>
                <a:gridCol w="649086"/>
                <a:gridCol w="649086"/>
                <a:gridCol w="702668"/>
                <a:gridCol w="710696"/>
                <a:gridCol w="1345253"/>
              </a:tblGrid>
              <a:tr h="216024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167" marR="6167" marT="616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Age (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y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ex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AST (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U/L)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ALT (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U/L)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GGT (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U/L)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Plt (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*10</a:t>
                      </a:r>
                      <a:r>
                        <a:rPr lang="en-US" sz="1200" b="0" i="0" u="none" strike="noStrike" baseline="30000" dirty="0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/l)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reatment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1602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BV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5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le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5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06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43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24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E</a:t>
                      </a:r>
                      <a:r>
                        <a:rPr lang="en-US" altLang="ja-JP" sz="1200" dirty="0" smtClean="0">
                          <a:solidFill>
                            <a:schemeClr val="tx1"/>
                          </a:solidFill>
                        </a:rPr>
                        <a:t>ntecavi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1602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4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le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7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9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9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98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E</a:t>
                      </a:r>
                      <a:r>
                        <a:rPr lang="en-US" altLang="ja-JP" sz="1200" dirty="0" smtClean="0">
                          <a:solidFill>
                            <a:schemeClr val="tx1"/>
                          </a:solidFill>
                        </a:rPr>
                        <a:t>ntecavir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16024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CV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1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le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7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6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0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11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PEG-IFN</a:t>
                      </a:r>
                      <a:r>
                        <a:rPr lang="en-US" sz="1200" b="0" i="0" u="none" strike="noStrike" baseline="3000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*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1602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3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emale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7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92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8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68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PEG-IFN/RBV/VAN</a:t>
                      </a:r>
                      <a:r>
                        <a:rPr lang="en-US" sz="1200" b="0" i="0" u="none" strike="noStrike" baseline="3000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*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1602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8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emale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5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1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8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25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DCV+ASV</a:t>
                      </a:r>
                      <a:r>
                        <a:rPr lang="en-US" sz="1200" b="0" i="0" u="none" strike="noStrike" baseline="3000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*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1602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3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le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0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4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7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63</a:t>
                      </a: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DCV+ASV</a:t>
                      </a:r>
                      <a:r>
                        <a:rPr lang="en-US" sz="1200" b="0" i="0" u="none" strike="noStrike" baseline="3000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*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6167" marR="6167" marT="616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692696" y="2784049"/>
            <a:ext cx="53285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aseline="30000" dirty="0"/>
              <a:t>*</a:t>
            </a:r>
            <a:r>
              <a:rPr lang="en-US" altLang="ja-JP" sz="1200" baseline="30000" dirty="0" smtClean="0"/>
              <a:t>1 </a:t>
            </a:r>
            <a:r>
              <a:rPr lang="en-US" altLang="ja-JP" sz="1200" dirty="0"/>
              <a:t>PEG-IFN, </a:t>
            </a:r>
            <a:r>
              <a:rPr lang="en-US" altLang="ja-JP" sz="1200" dirty="0" smtClean="0"/>
              <a:t>peginterferon</a:t>
            </a:r>
            <a:r>
              <a:rPr lang="en-US" altLang="ja-JP" sz="1200" dirty="0"/>
              <a:t>;</a:t>
            </a:r>
            <a:r>
              <a:rPr lang="en-US" altLang="ja-JP" sz="1200" dirty="0" smtClean="0"/>
              <a:t> </a:t>
            </a:r>
            <a:r>
              <a:rPr lang="en-US" altLang="ja-JP" sz="1200" baseline="30000" dirty="0" smtClean="0"/>
              <a:t>*2 </a:t>
            </a:r>
            <a:r>
              <a:rPr lang="en-US" altLang="ja-JP" sz="1200" dirty="0"/>
              <a:t>PEG-IFN/RBV/VAN, </a:t>
            </a:r>
            <a:r>
              <a:rPr lang="en-US" altLang="ja-JP" sz="1200" dirty="0" smtClean="0"/>
              <a:t>peginterferon/ribavirin/vaniprevir;</a:t>
            </a:r>
            <a:r>
              <a:rPr lang="en-US" altLang="ja-JP" sz="1200" baseline="30000" dirty="0" smtClean="0"/>
              <a:t> </a:t>
            </a:r>
            <a:r>
              <a:rPr lang="en-US" altLang="ja-JP" sz="1200" baseline="30000" dirty="0"/>
              <a:t>*3 </a:t>
            </a:r>
            <a:r>
              <a:rPr lang="en-US" altLang="ja-JP" sz="1200" dirty="0"/>
              <a:t>DCV+ASV, daclatasvir + </a:t>
            </a:r>
            <a:r>
              <a:rPr lang="en-US" altLang="ja-JP" sz="1200" dirty="0" smtClean="0"/>
              <a:t>asunaprevir</a:t>
            </a:r>
            <a:endParaRPr kumimoji="1" lang="ja-JP" alt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</Words>
  <Application>Microsoft Office PowerPoint</Application>
  <PresentationFormat>A4 210 x 297 mm</PresentationFormat>
  <Paragraphs>53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5-11-24T08:53:52Z</dcterms:created>
  <dcterms:modified xsi:type="dcterms:W3CDTF">2016-06-23T08:39:06Z</dcterms:modified>
</cp:coreProperties>
</file>